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63" r:id="rId2"/>
    <p:sldId id="265" r:id="rId3"/>
    <p:sldId id="266" r:id="rId4"/>
    <p:sldId id="264" r:id="rId5"/>
    <p:sldId id="271" r:id="rId6"/>
    <p:sldId id="268" r:id="rId7"/>
    <p:sldId id="269" r:id="rId8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54" d="100"/>
          <a:sy n="54" d="100"/>
        </p:scale>
        <p:origin x="2674" y="77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2529A2-8BF4-4772-BF06-0EBB599CA1DA}" type="datetimeFigureOut">
              <a:rPr lang="en-IN" smtClean="0"/>
              <a:t>28-04-2023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5970A46-388D-4284-99D6-1DB48B80EB9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965893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5970A46-388D-4284-99D6-1DB48B80EB9F}" type="slidenum">
              <a:rPr lang="en-IN" smtClean="0"/>
              <a:t>6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748887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4/2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3.emf"/><Relationship Id="rId7" Type="http://schemas.openxmlformats.org/officeDocument/2006/relationships/image" Target="../media/image5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7.emf"/><Relationship Id="rId5" Type="http://schemas.openxmlformats.org/officeDocument/2006/relationships/image" Target="../media/image4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6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8.emf"/><Relationship Id="rId7" Type="http://schemas.openxmlformats.org/officeDocument/2006/relationships/image" Target="../media/image10.emf"/><Relationship Id="rId2" Type="http://schemas.openxmlformats.org/officeDocument/2006/relationships/oleObject" Target="../embeddings/oleObject6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8.bin"/><Relationship Id="rId5" Type="http://schemas.openxmlformats.org/officeDocument/2006/relationships/image" Target="../media/image9.emf"/><Relationship Id="rId4" Type="http://schemas.openxmlformats.org/officeDocument/2006/relationships/oleObject" Target="../embeddings/oleObject7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emf"/><Relationship Id="rId3" Type="http://schemas.openxmlformats.org/officeDocument/2006/relationships/image" Target="../media/image13.tiff"/><Relationship Id="rId7" Type="http://schemas.openxmlformats.org/officeDocument/2006/relationships/oleObject" Target="../embeddings/oleObject10.bin"/><Relationship Id="rId12" Type="http://schemas.openxmlformats.org/officeDocument/2006/relationships/image" Target="../media/image18.emf"/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emf"/><Relationship Id="rId11" Type="http://schemas.openxmlformats.org/officeDocument/2006/relationships/oleObject" Target="../embeddings/oleObject12.bin"/><Relationship Id="rId5" Type="http://schemas.openxmlformats.org/officeDocument/2006/relationships/oleObject" Target="../embeddings/oleObject9.bin"/><Relationship Id="rId10" Type="http://schemas.openxmlformats.org/officeDocument/2006/relationships/image" Target="../media/image17.emf"/><Relationship Id="rId4" Type="http://schemas.openxmlformats.org/officeDocument/2006/relationships/image" Target="../media/image14.tiff"/><Relationship Id="rId9" Type="http://schemas.openxmlformats.org/officeDocument/2006/relationships/oleObject" Target="../embeddings/oleObject11.bin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1.tiff"/><Relationship Id="rId4" Type="http://schemas.openxmlformats.org/officeDocument/2006/relationships/image" Target="../media/image20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jpe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154E191-5670-4E98-92BB-384FABE14692}"/>
              </a:ext>
            </a:extLst>
          </p:cNvPr>
          <p:cNvSpPr txBox="1"/>
          <p:nvPr/>
        </p:nvSpPr>
        <p:spPr>
          <a:xfrm>
            <a:off x="103908" y="179340"/>
            <a:ext cx="6525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Table S1 -</a:t>
            </a: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List of NHR ligands and concentrations used.</a:t>
            </a:r>
            <a:endParaRPr lang="en-US" b="1" dirty="0"/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7328BD02-A940-779B-4B7C-C8570DF628A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7680098"/>
              </p:ext>
            </p:extLst>
          </p:nvPr>
        </p:nvGraphicFramePr>
        <p:xfrm>
          <a:off x="1066800" y="1262058"/>
          <a:ext cx="4876800" cy="483393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591462">
                  <a:extLst>
                    <a:ext uri="{9D8B030D-6E8A-4147-A177-3AD203B41FA5}">
                      <a16:colId xmlns:a16="http://schemas.microsoft.com/office/drawing/2014/main" val="14975449"/>
                    </a:ext>
                  </a:extLst>
                </a:gridCol>
                <a:gridCol w="1751322">
                  <a:extLst>
                    <a:ext uri="{9D8B030D-6E8A-4147-A177-3AD203B41FA5}">
                      <a16:colId xmlns:a16="http://schemas.microsoft.com/office/drawing/2014/main" val="2351500095"/>
                    </a:ext>
                  </a:extLst>
                </a:gridCol>
                <a:gridCol w="1534016">
                  <a:extLst>
                    <a:ext uri="{9D8B030D-6E8A-4147-A177-3AD203B41FA5}">
                      <a16:colId xmlns:a16="http://schemas.microsoft.com/office/drawing/2014/main" val="4287112149"/>
                    </a:ext>
                  </a:extLst>
                </a:gridCol>
              </a:tblGrid>
              <a:tr h="400935">
                <a:tc>
                  <a:txBody>
                    <a:bodyPr/>
                    <a:lstStyle/>
                    <a:p>
                      <a:pPr indent="102235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dirty="0">
                          <a:effectLst/>
                        </a:rPr>
                        <a:t>NHRs</a:t>
                      </a:r>
                      <a:endParaRPr lang="en-IN" sz="1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02235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dirty="0">
                          <a:effectLst/>
                        </a:rPr>
                        <a:t>Ligands </a:t>
                      </a:r>
                      <a:endParaRPr lang="en-IN" sz="1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02235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dirty="0">
                          <a:effectLst/>
                        </a:rPr>
                        <a:t>Concentrations</a:t>
                      </a:r>
                      <a:endParaRPr lang="en-IN" sz="1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203467015"/>
                  </a:ext>
                </a:extLst>
              </a:tr>
              <a:tr h="400935">
                <a:tc>
                  <a:txBody>
                    <a:bodyPr/>
                    <a:lstStyle/>
                    <a:p>
                      <a:pPr indent="102235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dirty="0">
                          <a:effectLst/>
                        </a:rPr>
                        <a:t>ESR1</a:t>
                      </a:r>
                      <a:endParaRPr lang="en-IN" sz="1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02235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</a:rPr>
                        <a:t>17-b-estradiol</a:t>
                      </a:r>
                      <a:endParaRPr lang="en-IN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02235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</a:rPr>
                        <a:t>100 &amp; 200 nM</a:t>
                      </a:r>
                      <a:endParaRPr lang="en-IN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470752555"/>
                  </a:ext>
                </a:extLst>
              </a:tr>
              <a:tr h="400935">
                <a:tc>
                  <a:txBody>
                    <a:bodyPr/>
                    <a:lstStyle/>
                    <a:p>
                      <a:pPr indent="102235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dirty="0" err="1">
                          <a:effectLst/>
                        </a:rPr>
                        <a:t>PPARg</a:t>
                      </a:r>
                      <a:endParaRPr lang="en-IN" sz="1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02235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</a:rPr>
                        <a:t>Rosiglitazone</a:t>
                      </a:r>
                      <a:endParaRPr lang="en-IN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02235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</a:rPr>
                        <a:t>10 &amp; 20 uM</a:t>
                      </a:r>
                      <a:endParaRPr lang="en-IN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358562469"/>
                  </a:ext>
                </a:extLst>
              </a:tr>
              <a:tr h="596292">
                <a:tc rowSpan="2">
                  <a:txBody>
                    <a:bodyPr/>
                    <a:lstStyle/>
                    <a:p>
                      <a:pPr indent="102235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dirty="0">
                          <a:effectLst/>
                        </a:rPr>
                        <a:t>RXRA &amp; RARA</a:t>
                      </a:r>
                      <a:endParaRPr lang="en-IN" sz="1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02235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</a:rPr>
                        <a:t>9cis retinoic acid (9cRA)</a:t>
                      </a:r>
                      <a:endParaRPr lang="en-IN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02235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</a:rPr>
                        <a:t>0.5 &amp; 1.0 uM</a:t>
                      </a:r>
                      <a:endParaRPr lang="en-IN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43666694"/>
                  </a:ext>
                </a:extLst>
              </a:tr>
              <a:tr h="817772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102235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</a:rPr>
                        <a:t>All-trans retinoic acid (ATRA)</a:t>
                      </a:r>
                      <a:endParaRPr lang="en-IN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02235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</a:rPr>
                        <a:t>0.5 &amp; 1.0 uM</a:t>
                      </a:r>
                      <a:endParaRPr lang="en-IN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305219415"/>
                  </a:ext>
                </a:extLst>
              </a:tr>
              <a:tr h="400935">
                <a:tc rowSpan="3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dirty="0">
                          <a:effectLst/>
                        </a:rPr>
                        <a:t>RXRA &amp; RXRB</a:t>
                      </a:r>
                      <a:endParaRPr lang="en-IN" sz="1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02235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</a:rPr>
                        <a:t>Acitretin </a:t>
                      </a:r>
                      <a:endParaRPr lang="en-IN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02235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</a:rPr>
                        <a:t>1.0 &amp; 5.0 uM</a:t>
                      </a:r>
                      <a:endParaRPr lang="en-IN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666534564"/>
                  </a:ext>
                </a:extLst>
              </a:tr>
              <a:tr h="400935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102235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</a:rPr>
                        <a:t>Bexarotene</a:t>
                      </a:r>
                      <a:endParaRPr lang="en-IN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02235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</a:rPr>
                        <a:t>1.0 &amp; 10uM</a:t>
                      </a:r>
                      <a:endParaRPr lang="en-IN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145065184"/>
                  </a:ext>
                </a:extLst>
              </a:tr>
              <a:tr h="400935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102235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</a:rPr>
                        <a:t>SR11237</a:t>
                      </a:r>
                      <a:endParaRPr lang="en-IN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02235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</a:rPr>
                        <a:t>1.0 &amp; 2.0 uM</a:t>
                      </a:r>
                      <a:endParaRPr lang="en-IN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906503237"/>
                  </a:ext>
                </a:extLst>
              </a:tr>
              <a:tr h="400935">
                <a:tc>
                  <a:txBody>
                    <a:bodyPr/>
                    <a:lstStyle/>
                    <a:p>
                      <a:pPr indent="102235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dirty="0">
                          <a:effectLst/>
                        </a:rPr>
                        <a:t>THRA</a:t>
                      </a:r>
                      <a:endParaRPr lang="en-IN" sz="1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02235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</a:rPr>
                        <a:t>Tri-iodo-thyronine</a:t>
                      </a:r>
                      <a:endParaRPr lang="en-IN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02235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</a:rPr>
                        <a:t>1 &amp; 10 </a:t>
                      </a:r>
                      <a:r>
                        <a:rPr lang="en-US" sz="1400" dirty="0" err="1">
                          <a:effectLst/>
                        </a:rPr>
                        <a:t>uM</a:t>
                      </a:r>
                      <a:endParaRPr lang="en-IN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292317212"/>
                  </a:ext>
                </a:extLst>
              </a:tr>
              <a:tr h="306665">
                <a:tc>
                  <a:txBody>
                    <a:bodyPr/>
                    <a:lstStyle/>
                    <a:p>
                      <a:pPr indent="102235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dirty="0">
                          <a:effectLst/>
                        </a:rPr>
                        <a:t>ESRRG</a:t>
                      </a:r>
                      <a:endParaRPr lang="en-IN" sz="1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02235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</a:rPr>
                        <a:t>GSK4716</a:t>
                      </a:r>
                      <a:endParaRPr lang="en-IN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02235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</a:rPr>
                        <a:t>10 &amp; 20uM</a:t>
                      </a:r>
                      <a:endParaRPr lang="en-IN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953712787"/>
                  </a:ext>
                </a:extLst>
              </a:tr>
              <a:tr h="306665">
                <a:tc>
                  <a:txBody>
                    <a:bodyPr/>
                    <a:lstStyle/>
                    <a:p>
                      <a:pPr indent="102235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dirty="0">
                          <a:effectLst/>
                        </a:rPr>
                        <a:t>AR</a:t>
                      </a:r>
                      <a:endParaRPr lang="en-IN" sz="1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02235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</a:rPr>
                        <a:t>Stanozolol</a:t>
                      </a:r>
                      <a:endParaRPr lang="en-IN" sz="1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indent="102235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</a:rPr>
                        <a:t>5 &amp; 10 </a:t>
                      </a:r>
                      <a:r>
                        <a:rPr lang="en-US" sz="1400" dirty="0" err="1">
                          <a:effectLst/>
                        </a:rPr>
                        <a:t>uM</a:t>
                      </a:r>
                      <a:endParaRPr lang="en-IN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60509778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465725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9D30643E-BBF2-41D2-9B3B-217657F907C0}"/>
              </a:ext>
            </a:extLst>
          </p:cNvPr>
          <p:cNvSpPr/>
          <p:nvPr/>
        </p:nvSpPr>
        <p:spPr>
          <a:xfrm>
            <a:off x="382402" y="71639"/>
            <a:ext cx="632319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N" sz="1400" b="1" dirty="0"/>
              <a:t>Figure S1 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06A08214-0F0B-159B-9C92-32960A67E40D}"/>
              </a:ext>
            </a:extLst>
          </p:cNvPr>
          <p:cNvGrpSpPr/>
          <p:nvPr/>
        </p:nvGrpSpPr>
        <p:grpSpPr>
          <a:xfrm>
            <a:off x="267401" y="1066800"/>
            <a:ext cx="6323198" cy="8255701"/>
            <a:chOff x="1172887" y="1700398"/>
            <a:chExt cx="3960095" cy="6505203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861CD444-3EFA-47F1-878E-4C77773FFD7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6176" t="11809" r="80982" b="38477"/>
            <a:stretch/>
          </p:blipFill>
          <p:spPr>
            <a:xfrm rot="5400000">
              <a:off x="3895727" y="1071413"/>
              <a:ext cx="144000" cy="141634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C9FB35D6-C76D-4690-9AB4-6E59EB490F0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9821" t="32381" r="574" b="38900"/>
            <a:stretch/>
          </p:blipFill>
          <p:spPr>
            <a:xfrm rot="5400000">
              <a:off x="823788" y="4422323"/>
              <a:ext cx="6287880" cy="127603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405751C5-B163-451A-A16F-08B5FE76F1A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0213" t="36566" r="839" b="38788"/>
            <a:stretch/>
          </p:blipFill>
          <p:spPr>
            <a:xfrm rot="5400000">
              <a:off x="-774475" y="4508793"/>
              <a:ext cx="6289200" cy="110441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7FEE9E40-ADE3-4301-B5CA-59F47F8CD7B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6471" t="14330" r="81075" b="43551"/>
            <a:stretch/>
          </p:blipFill>
          <p:spPr>
            <a:xfrm rot="5400000">
              <a:off x="2299714" y="1077084"/>
              <a:ext cx="144000" cy="139062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824657D3-229E-4FD0-A72E-CCB3B125F6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0213" t="36566" r="839" b="38788"/>
            <a:stretch/>
          </p:blipFill>
          <p:spPr>
            <a:xfrm rot="5400000">
              <a:off x="-774475" y="4508794"/>
              <a:ext cx="6289200" cy="110441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37F1F401-D14B-43C5-970A-7683C3887D9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0213" t="36566" r="839" b="38788"/>
            <a:stretch/>
          </p:blipFill>
          <p:spPr>
            <a:xfrm rot="5400000">
              <a:off x="-774475" y="4508795"/>
              <a:ext cx="6289200" cy="110441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2" name="Left Arrow 11"/>
            <p:cNvSpPr/>
            <p:nvPr/>
          </p:nvSpPr>
          <p:spPr>
            <a:xfrm rot="10800000">
              <a:off x="1189450" y="7683766"/>
              <a:ext cx="506896" cy="45719"/>
            </a:xfrm>
            <a:prstGeom prst="leftArrow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Left Arrow 12"/>
            <p:cNvSpPr/>
            <p:nvPr/>
          </p:nvSpPr>
          <p:spPr>
            <a:xfrm rot="10800000">
              <a:off x="1174697" y="6928393"/>
              <a:ext cx="506896" cy="53466"/>
            </a:xfrm>
            <a:prstGeom prst="leftArrow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Left Arrow 13"/>
            <p:cNvSpPr/>
            <p:nvPr/>
          </p:nvSpPr>
          <p:spPr>
            <a:xfrm rot="10800000">
              <a:off x="1222513" y="4860144"/>
              <a:ext cx="506896" cy="45719"/>
            </a:xfrm>
            <a:prstGeom prst="leftArrow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Left Arrow 14"/>
            <p:cNvSpPr/>
            <p:nvPr/>
          </p:nvSpPr>
          <p:spPr>
            <a:xfrm>
              <a:off x="4675898" y="4860143"/>
              <a:ext cx="457084" cy="45720"/>
            </a:xfrm>
            <a:prstGeom prst="leftArrow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Left Arrow 15"/>
            <p:cNvSpPr/>
            <p:nvPr/>
          </p:nvSpPr>
          <p:spPr>
            <a:xfrm rot="10800000">
              <a:off x="1265584" y="3591248"/>
              <a:ext cx="506896" cy="45719"/>
            </a:xfrm>
            <a:prstGeom prst="leftArrow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Left Arrow 16"/>
            <p:cNvSpPr/>
            <p:nvPr/>
          </p:nvSpPr>
          <p:spPr>
            <a:xfrm>
              <a:off x="4709030" y="6831402"/>
              <a:ext cx="414013" cy="45719"/>
            </a:xfrm>
            <a:prstGeom prst="leftArrow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Left Arrow 17"/>
            <p:cNvSpPr/>
            <p:nvPr/>
          </p:nvSpPr>
          <p:spPr>
            <a:xfrm rot="10800000">
              <a:off x="1172887" y="7508179"/>
              <a:ext cx="506896" cy="45719"/>
            </a:xfrm>
            <a:prstGeom prst="leftArrow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Left Arrow 18"/>
            <p:cNvSpPr/>
            <p:nvPr/>
          </p:nvSpPr>
          <p:spPr>
            <a:xfrm rot="10800000">
              <a:off x="1268899" y="3461380"/>
              <a:ext cx="506896" cy="59634"/>
            </a:xfrm>
            <a:prstGeom prst="leftArrow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Left Arrow 19"/>
            <p:cNvSpPr/>
            <p:nvPr/>
          </p:nvSpPr>
          <p:spPr>
            <a:xfrm rot="10800000">
              <a:off x="1278838" y="4063286"/>
              <a:ext cx="506896" cy="64012"/>
            </a:xfrm>
            <a:prstGeom prst="leftArrow">
              <a:avLst/>
            </a:prstGeom>
            <a:solidFill>
              <a:srgbClr val="C00000"/>
            </a:solidFill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6727800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070B2392-09BC-4E22-9B64-B3D5094E4FB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3513438"/>
              </p:ext>
            </p:extLst>
          </p:nvPr>
        </p:nvGraphicFramePr>
        <p:xfrm>
          <a:off x="409575" y="1432800"/>
          <a:ext cx="2903537" cy="2679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2" imgW="3550589" imgH="3192500" progId="Prism7.Document">
                  <p:embed/>
                </p:oleObj>
              </mc:Choice>
              <mc:Fallback>
                <p:oleObj name="Prism 7" r:id="rId2" imgW="3550589" imgH="3192500" progId="Prism7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070B2392-09BC-4E22-9B64-B3D5094E4FB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09575" y="1432800"/>
                        <a:ext cx="2903537" cy="2679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58F99003-2237-4328-8E4A-73CCE145008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05117213"/>
              </p:ext>
            </p:extLst>
          </p:nvPr>
        </p:nvGraphicFramePr>
        <p:xfrm>
          <a:off x="3600450" y="1401050"/>
          <a:ext cx="2800350" cy="25511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4" imgW="3550589" imgH="3151464" progId="Prism7.Document">
                  <p:embed/>
                </p:oleObj>
              </mc:Choice>
              <mc:Fallback>
                <p:oleObj name="Prism 7" r:id="rId4" imgW="3550589" imgH="3151464" progId="Prism7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58F99003-2237-4328-8E4A-73CCE145008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600450" y="1401050"/>
                        <a:ext cx="2800350" cy="25511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07CD6258-8B85-4CB8-B220-9DD210D7167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4548613"/>
              </p:ext>
            </p:extLst>
          </p:nvPr>
        </p:nvGraphicFramePr>
        <p:xfrm>
          <a:off x="390525" y="4091862"/>
          <a:ext cx="2882900" cy="2513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6" imgW="3550589" imgH="3020078" progId="Prism7.Document">
                  <p:embed/>
                </p:oleObj>
              </mc:Choice>
              <mc:Fallback>
                <p:oleObj name="Prism 7" r:id="rId6" imgW="3550589" imgH="3020078" progId="Prism7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07CD6258-8B85-4CB8-B220-9DD210D7167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90525" y="4091862"/>
                        <a:ext cx="2882900" cy="2513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28238A9B-1A70-41E2-A04F-6B452469282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95073004"/>
              </p:ext>
            </p:extLst>
          </p:nvPr>
        </p:nvGraphicFramePr>
        <p:xfrm>
          <a:off x="3581400" y="4091862"/>
          <a:ext cx="2881312" cy="2513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8" imgW="3550589" imgH="3020078" progId="Prism7.Document">
                  <p:embed/>
                </p:oleObj>
              </mc:Choice>
              <mc:Fallback>
                <p:oleObj name="Prism 7" r:id="rId8" imgW="3550589" imgH="3020078" progId="Prism7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28238A9B-1A70-41E2-A04F-6B452469282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581400" y="4091862"/>
                        <a:ext cx="2881312" cy="2513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7">
            <a:extLst>
              <a:ext uri="{FF2B5EF4-FFF2-40B4-BE49-F238E27FC236}">
                <a16:creationId xmlns:a16="http://schemas.microsoft.com/office/drawing/2014/main" id="{4E75131A-8BF5-4F4A-9926-7C88E27C6835}"/>
              </a:ext>
            </a:extLst>
          </p:cNvPr>
          <p:cNvSpPr/>
          <p:nvPr/>
        </p:nvSpPr>
        <p:spPr>
          <a:xfrm>
            <a:off x="2233351" y="1819653"/>
            <a:ext cx="87075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/>
              <a:t>p=0.0515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F8A7E49A-23C6-4588-A3E4-48CFD760DA70}"/>
              </a:ext>
            </a:extLst>
          </p:cNvPr>
          <p:cNvSpPr/>
          <p:nvPr/>
        </p:nvSpPr>
        <p:spPr>
          <a:xfrm>
            <a:off x="5449887" y="1817008"/>
            <a:ext cx="87556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/>
              <a:t>p=0.4107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B9333F4D-D29C-4EBB-93D8-03AB8F11A8F2}"/>
              </a:ext>
            </a:extLst>
          </p:cNvPr>
          <p:cNvSpPr/>
          <p:nvPr/>
        </p:nvSpPr>
        <p:spPr>
          <a:xfrm>
            <a:off x="5487987" y="4428576"/>
            <a:ext cx="90074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p=0.9066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3A9E96B5-A46F-421E-92BC-1E522EFF1D2D}"/>
              </a:ext>
            </a:extLst>
          </p:cNvPr>
          <p:cNvSpPr/>
          <p:nvPr/>
        </p:nvSpPr>
        <p:spPr>
          <a:xfrm>
            <a:off x="2261565" y="4370051"/>
            <a:ext cx="87075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b="1" dirty="0"/>
              <a:t>p=0.0337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C984A39-F6F2-4338-A267-D63CF73B46F9}"/>
              </a:ext>
            </a:extLst>
          </p:cNvPr>
          <p:cNvSpPr txBox="1"/>
          <p:nvPr/>
        </p:nvSpPr>
        <p:spPr>
          <a:xfrm>
            <a:off x="-19060" y="606895"/>
            <a:ext cx="65849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ure S2</a:t>
            </a:r>
          </a:p>
        </p:txBody>
      </p:sp>
      <p:grpSp>
        <p:nvGrpSpPr>
          <p:cNvPr id="17" name="Group 16">
            <a:extLst>
              <a:ext uri="{FF2B5EF4-FFF2-40B4-BE49-F238E27FC236}">
                <a16:creationId xmlns:a16="http://schemas.microsoft.com/office/drawing/2014/main" id="{81619E18-6A77-4794-8F62-6CFCA378B7BD}"/>
              </a:ext>
            </a:extLst>
          </p:cNvPr>
          <p:cNvGrpSpPr/>
          <p:nvPr/>
        </p:nvGrpSpPr>
        <p:grpSpPr>
          <a:xfrm>
            <a:off x="1971675" y="6454775"/>
            <a:ext cx="3116263" cy="2574925"/>
            <a:chOff x="-6170152" y="6426053"/>
            <a:chExt cx="3555538" cy="3075692"/>
          </a:xfrm>
        </p:grpSpPr>
        <p:graphicFrame>
          <p:nvGraphicFramePr>
            <p:cNvPr id="18" name="Object 17">
              <a:extLst>
                <a:ext uri="{FF2B5EF4-FFF2-40B4-BE49-F238E27FC236}">
                  <a16:creationId xmlns:a16="http://schemas.microsoft.com/office/drawing/2014/main" id="{BFA99132-19B2-4B91-BC11-8F6182026D6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62091299"/>
                </p:ext>
              </p:extLst>
            </p:nvPr>
          </p:nvGraphicFramePr>
          <p:xfrm>
            <a:off x="-6170152" y="6426053"/>
            <a:ext cx="3555538" cy="307569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7" r:id="rId10" imgW="3554909" imgH="3075152" progId="Prism7.Document">
                    <p:embed/>
                  </p:oleObj>
                </mc:Choice>
                <mc:Fallback>
                  <p:oleObj name="Prism 7" r:id="rId10" imgW="3554909" imgH="3075152" progId="Prism7.Document">
                    <p:embed/>
                    <p:pic>
                      <p:nvPicPr>
                        <p:cNvPr id="18" name="Object 17">
                          <a:extLst>
                            <a:ext uri="{FF2B5EF4-FFF2-40B4-BE49-F238E27FC236}">
                              <a16:creationId xmlns:a16="http://schemas.microsoft.com/office/drawing/2014/main" id="{BFA99132-19B2-4B91-BC11-8F6182026D6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-6170152" y="6426053"/>
                          <a:ext cx="3555538" cy="307569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869DDBE6-5332-42A4-8139-B60F4E5313D6}"/>
                </a:ext>
              </a:extLst>
            </p:cNvPr>
            <p:cNvSpPr/>
            <p:nvPr/>
          </p:nvSpPr>
          <p:spPr>
            <a:xfrm>
              <a:off x="-3973774" y="6658364"/>
              <a:ext cx="998982" cy="36763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/>
                <a:t>p&lt;0.0001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069549D7-4A8F-CCF0-B491-581A6B8DDDFD}"/>
              </a:ext>
            </a:extLst>
          </p:cNvPr>
          <p:cNvSpPr txBox="1"/>
          <p:nvPr/>
        </p:nvSpPr>
        <p:spPr>
          <a:xfrm>
            <a:off x="316186" y="1251116"/>
            <a:ext cx="342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B8955DC-19DC-747F-A90E-BE83CFB537DC}"/>
              </a:ext>
            </a:extLst>
          </p:cNvPr>
          <p:cNvSpPr txBox="1"/>
          <p:nvPr/>
        </p:nvSpPr>
        <p:spPr>
          <a:xfrm>
            <a:off x="3530292" y="1261987"/>
            <a:ext cx="342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243A313-93A1-C066-967D-D5F8B148038F}"/>
              </a:ext>
            </a:extLst>
          </p:cNvPr>
          <p:cNvSpPr txBox="1"/>
          <p:nvPr/>
        </p:nvSpPr>
        <p:spPr>
          <a:xfrm>
            <a:off x="323108" y="3992302"/>
            <a:ext cx="342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A320F9E-A073-1E30-FE01-75843B281D36}"/>
              </a:ext>
            </a:extLst>
          </p:cNvPr>
          <p:cNvSpPr txBox="1"/>
          <p:nvPr/>
        </p:nvSpPr>
        <p:spPr>
          <a:xfrm>
            <a:off x="3553797" y="4000719"/>
            <a:ext cx="342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E1EAB31-22D6-ADF4-5310-F8895643BC90}"/>
              </a:ext>
            </a:extLst>
          </p:cNvPr>
          <p:cNvSpPr txBox="1"/>
          <p:nvPr/>
        </p:nvSpPr>
        <p:spPr>
          <a:xfrm>
            <a:off x="1645136" y="6562520"/>
            <a:ext cx="342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11988589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B55F44B-F139-40AB-AC1F-1A8338D221A3}"/>
              </a:ext>
            </a:extLst>
          </p:cNvPr>
          <p:cNvSpPr txBox="1"/>
          <p:nvPr/>
        </p:nvSpPr>
        <p:spPr>
          <a:xfrm>
            <a:off x="124797" y="74535"/>
            <a:ext cx="67332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ure S3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9C860F8-809A-4B91-B82B-B247F6DEABC9}"/>
              </a:ext>
            </a:extLst>
          </p:cNvPr>
          <p:cNvSpPr txBox="1"/>
          <p:nvPr/>
        </p:nvSpPr>
        <p:spPr>
          <a:xfrm>
            <a:off x="28575" y="3697341"/>
            <a:ext cx="67332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ure S4 </a:t>
            </a:r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25E21A04-55A3-4841-B2BC-D690653428F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40326597"/>
              </p:ext>
            </p:extLst>
          </p:nvPr>
        </p:nvGraphicFramePr>
        <p:xfrm>
          <a:off x="3429000" y="4404532"/>
          <a:ext cx="3357562" cy="24844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2" imgW="3881027" imgH="2873934" progId="Prism7.Document">
                  <p:embed/>
                </p:oleObj>
              </mc:Choice>
              <mc:Fallback>
                <p:oleObj name="Prism 7" r:id="rId2" imgW="3881027" imgH="2873934" progId="Prism7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25E21A04-55A3-4841-B2BC-D690653428F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429000" y="4404532"/>
                        <a:ext cx="3357562" cy="24844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E5FE01B-5280-928E-D751-2112BCBF85D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42246788"/>
              </p:ext>
            </p:extLst>
          </p:nvPr>
        </p:nvGraphicFramePr>
        <p:xfrm>
          <a:off x="47624" y="7070252"/>
          <a:ext cx="3335338" cy="2332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4" imgW="4076122" imgH="2851256" progId="Prism7.Document">
                  <p:embed/>
                </p:oleObj>
              </mc:Choice>
              <mc:Fallback>
                <p:oleObj name="Prism 7" r:id="rId4" imgW="4076122" imgH="2851256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7624" y="7070252"/>
                        <a:ext cx="3335338" cy="23320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1179CCF2-82EE-F88B-1B5E-7C0AD552F8D9}"/>
              </a:ext>
            </a:extLst>
          </p:cNvPr>
          <p:cNvSpPr txBox="1"/>
          <p:nvPr/>
        </p:nvSpPr>
        <p:spPr>
          <a:xfrm>
            <a:off x="38372" y="4036404"/>
            <a:ext cx="342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04B82B0-7DDB-A9A6-5BB0-30FC56C12C8E}"/>
              </a:ext>
            </a:extLst>
          </p:cNvPr>
          <p:cNvSpPr txBox="1"/>
          <p:nvPr/>
        </p:nvSpPr>
        <p:spPr>
          <a:xfrm>
            <a:off x="3272421" y="4036404"/>
            <a:ext cx="342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DF626CE-E62F-C9FA-5C7A-2E6F6971BFEE}"/>
              </a:ext>
            </a:extLst>
          </p:cNvPr>
          <p:cNvSpPr txBox="1"/>
          <p:nvPr/>
        </p:nvSpPr>
        <p:spPr>
          <a:xfrm>
            <a:off x="71438" y="6786985"/>
            <a:ext cx="342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8F62696D-242F-A5DD-8FF4-4350D88C7C2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56207762"/>
              </p:ext>
            </p:extLst>
          </p:nvPr>
        </p:nvGraphicFramePr>
        <p:xfrm>
          <a:off x="-20637" y="4377161"/>
          <a:ext cx="3487737" cy="24050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6" imgW="4134075" imgH="2851256" progId="Prism7.Document">
                  <p:embed/>
                </p:oleObj>
              </mc:Choice>
              <mc:Fallback>
                <p:oleObj name="Prism 7" r:id="rId6" imgW="4134075" imgH="2851256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-20637" y="4377161"/>
                        <a:ext cx="3487737" cy="24050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3" name="Picture 12">
            <a:extLst>
              <a:ext uri="{FF2B5EF4-FFF2-40B4-BE49-F238E27FC236}">
                <a16:creationId xmlns:a16="http://schemas.microsoft.com/office/drawing/2014/main" id="{9436BB8D-A175-42BD-41D5-E3DE8EC22FE0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7952"/>
          <a:stretch/>
        </p:blipFill>
        <p:spPr>
          <a:xfrm>
            <a:off x="1281904" y="175700"/>
            <a:ext cx="3981033" cy="35241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11876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8" descr="C:\Users\BD Accuri\Desktop\cml nhr figures\PPARG 1.tif">
            <a:extLst>
              <a:ext uri="{FF2B5EF4-FFF2-40B4-BE49-F238E27FC236}">
                <a16:creationId xmlns:a16="http://schemas.microsoft.com/office/drawing/2014/main" id="{C14EC1D5-27FF-B00B-9641-1BD99A28374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5228"/>
          <a:stretch/>
        </p:blipFill>
        <p:spPr bwMode="auto">
          <a:xfrm>
            <a:off x="4084575" y="1216460"/>
            <a:ext cx="2165227" cy="226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67799EAB-245B-D453-DFE5-E4C76C5B7C03}"/>
              </a:ext>
            </a:extLst>
          </p:cNvPr>
          <p:cNvGrpSpPr/>
          <p:nvPr/>
        </p:nvGrpSpPr>
        <p:grpSpPr>
          <a:xfrm>
            <a:off x="106597" y="1216460"/>
            <a:ext cx="2427101" cy="2268000"/>
            <a:chOff x="443184" y="703828"/>
            <a:chExt cx="2427101" cy="2268000"/>
          </a:xfrm>
        </p:grpSpPr>
        <p:pic>
          <p:nvPicPr>
            <p:cNvPr id="6" name="Picture 9" descr="C:\Users\BD Accuri\Desktop\cml nhr figures\RARA.tif">
              <a:extLst>
                <a:ext uri="{FF2B5EF4-FFF2-40B4-BE49-F238E27FC236}">
                  <a16:creationId xmlns:a16="http://schemas.microsoft.com/office/drawing/2014/main" id="{52B38EB8-05E0-A940-C221-A4A22622994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3184" y="703828"/>
              <a:ext cx="2427101" cy="2268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C1249C7-29FE-1E68-6311-DCD92829EB12}"/>
                </a:ext>
              </a:extLst>
            </p:cNvPr>
            <p:cNvSpPr txBox="1"/>
            <p:nvPr/>
          </p:nvSpPr>
          <p:spPr>
            <a:xfrm>
              <a:off x="1550373" y="1049410"/>
              <a:ext cx="4650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/>
                <a:t>***</a:t>
              </a: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19AB1D83-D434-C078-5AAF-126ED19A061B}"/>
              </a:ext>
            </a:extLst>
          </p:cNvPr>
          <p:cNvGrpSpPr/>
          <p:nvPr/>
        </p:nvGrpSpPr>
        <p:grpSpPr>
          <a:xfrm>
            <a:off x="2085182" y="1245063"/>
            <a:ext cx="2456073" cy="2268000"/>
            <a:chOff x="2224855" y="876828"/>
            <a:chExt cx="2456073" cy="2257254"/>
          </a:xfrm>
        </p:grpSpPr>
        <p:pic>
          <p:nvPicPr>
            <p:cNvPr id="4" name="Picture 7" descr="C:\Users\BD Accuri\Desktop\cml nhr figures\VDR.tif">
              <a:extLst>
                <a:ext uri="{FF2B5EF4-FFF2-40B4-BE49-F238E27FC236}">
                  <a16:creationId xmlns:a16="http://schemas.microsoft.com/office/drawing/2014/main" id="{3D768488-4B77-D934-662B-6F605394AB7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24855" y="876828"/>
              <a:ext cx="2456073" cy="225725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68BBFB93-689A-AB06-F776-592890EEE60C}"/>
                </a:ext>
              </a:extLst>
            </p:cNvPr>
            <p:cNvSpPr txBox="1"/>
            <p:nvPr/>
          </p:nvSpPr>
          <p:spPr>
            <a:xfrm>
              <a:off x="3299305" y="964630"/>
              <a:ext cx="6018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/>
                <a:t>***</a:t>
              </a: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394C38DB-D931-ABFF-E51C-D62C8E18A05E}"/>
              </a:ext>
            </a:extLst>
          </p:cNvPr>
          <p:cNvSpPr txBox="1"/>
          <p:nvPr/>
        </p:nvSpPr>
        <p:spPr>
          <a:xfrm>
            <a:off x="71335" y="219893"/>
            <a:ext cx="66850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ure S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188B086-6FE0-3715-9399-AC488034F2C5}"/>
              </a:ext>
            </a:extLst>
          </p:cNvPr>
          <p:cNvSpPr txBox="1"/>
          <p:nvPr/>
        </p:nvSpPr>
        <p:spPr>
          <a:xfrm>
            <a:off x="159940" y="3489182"/>
            <a:ext cx="65078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/>
              <a:t>Figure S6</a:t>
            </a:r>
          </a:p>
        </p:txBody>
      </p: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422077C0-1978-D7A7-8BE0-64ADD3B5549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4918208"/>
              </p:ext>
            </p:extLst>
          </p:nvPr>
        </p:nvGraphicFramePr>
        <p:xfrm>
          <a:off x="9525" y="4367212"/>
          <a:ext cx="3582988" cy="28082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5" imgW="3791398" imgH="2970043" progId="Prism7.Document">
                  <p:embed/>
                </p:oleObj>
              </mc:Choice>
              <mc:Fallback>
                <p:oleObj name="Prism 7" r:id="rId5" imgW="3791398" imgH="2970043" progId="Prism7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E736245D-6FB2-BD8F-B5AF-A7FA88BD8B4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9525" y="4367212"/>
                        <a:ext cx="3582988" cy="28082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95A40975-A3DD-7BAE-EC64-C2B7575660B3}"/>
              </a:ext>
            </a:extLst>
          </p:cNvPr>
          <p:cNvSpPr txBox="1"/>
          <p:nvPr/>
        </p:nvSpPr>
        <p:spPr>
          <a:xfrm rot="16200000">
            <a:off x="676390" y="4826176"/>
            <a:ext cx="7837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CL22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id="{6EAFC551-A44B-F7AE-8211-1A52C70C54C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62838871"/>
              </p:ext>
            </p:extLst>
          </p:nvPr>
        </p:nvGraphicFramePr>
        <p:xfrm>
          <a:off x="1251457" y="5330076"/>
          <a:ext cx="1422400" cy="220980"/>
        </p:xfrm>
        <a:graphic>
          <a:graphicData uri="http://schemas.openxmlformats.org/drawingml/2006/table">
            <a:tbl>
              <a:tblPr/>
              <a:tblGrid>
                <a:gridCol w="1422400">
                  <a:extLst>
                    <a:ext uri="{9D8B030D-6E8A-4147-A177-3AD203B41FA5}">
                      <a16:colId xmlns:a16="http://schemas.microsoft.com/office/drawing/2014/main" val="922013210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IN" sz="1400" b="0" i="0" u="none" strike="noStrike" dirty="0">
                          <a:effectLst/>
                          <a:latin typeface="Arial" panose="020B0604020202020204" pitchFamily="34" charset="0"/>
                        </a:rPr>
                        <a:t>*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2348135"/>
                  </a:ext>
                </a:extLst>
              </a:tr>
            </a:tbl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9725F5CB-7424-BA56-107C-852CFD8C462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72822543"/>
              </p:ext>
            </p:extLst>
          </p:nvPr>
        </p:nvGraphicFramePr>
        <p:xfrm>
          <a:off x="3360738" y="4376737"/>
          <a:ext cx="3584575" cy="2733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7" imgW="3791398" imgH="2892292" progId="Prism7.Document">
                  <p:embed/>
                </p:oleObj>
              </mc:Choice>
              <mc:Fallback>
                <p:oleObj name="Prism 7" r:id="rId7" imgW="3791398" imgH="2892292" progId="Prism7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04D6C25F-174C-6006-1224-A03497F8D02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360738" y="4376737"/>
                        <a:ext cx="3584575" cy="2733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1715915B-3E49-556C-8CFE-D640B313719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55748704"/>
              </p:ext>
            </p:extLst>
          </p:nvPr>
        </p:nvGraphicFramePr>
        <p:xfrm>
          <a:off x="11113" y="7145337"/>
          <a:ext cx="3421063" cy="26558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9" imgW="3791398" imgH="2940886" progId="Prism7.Document">
                  <p:embed/>
                </p:oleObj>
              </mc:Choice>
              <mc:Fallback>
                <p:oleObj name="Prism 7" r:id="rId9" imgW="3791398" imgH="2940886" progId="Prism7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8DC5728A-365D-6C9C-2838-1E17AC8852F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1113" y="7145337"/>
                        <a:ext cx="3421063" cy="26558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33395132-E4C9-CB18-A737-B1F6171F6D19}"/>
              </a:ext>
            </a:extLst>
          </p:cNvPr>
          <p:cNvSpPr txBox="1"/>
          <p:nvPr/>
        </p:nvSpPr>
        <p:spPr>
          <a:xfrm rot="16200000">
            <a:off x="676389" y="7534322"/>
            <a:ext cx="7837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ama84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869F072C-573A-5CF8-F841-163E353D757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5705645"/>
              </p:ext>
            </p:extLst>
          </p:nvPr>
        </p:nvGraphicFramePr>
        <p:xfrm>
          <a:off x="3360738" y="7146925"/>
          <a:ext cx="3584575" cy="27352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11" imgW="3791398" imgH="2892292" progId="Prism7.Document">
                  <p:embed/>
                </p:oleObj>
              </mc:Choice>
              <mc:Fallback>
                <p:oleObj name="Prism 7" r:id="rId11" imgW="3791398" imgH="2892292" progId="Prism7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E760DA7C-EBF7-4726-B0C4-6B57539C8F4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360738" y="7146925"/>
                        <a:ext cx="3584575" cy="27352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Table 17">
            <a:extLst>
              <a:ext uri="{FF2B5EF4-FFF2-40B4-BE49-F238E27FC236}">
                <a16:creationId xmlns:a16="http://schemas.microsoft.com/office/drawing/2014/main" id="{DD408E8D-C77D-BC53-97D1-8E2672F6915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70657464"/>
              </p:ext>
            </p:extLst>
          </p:nvPr>
        </p:nvGraphicFramePr>
        <p:xfrm>
          <a:off x="2171288" y="7479392"/>
          <a:ext cx="1066800" cy="220980"/>
        </p:xfrm>
        <a:graphic>
          <a:graphicData uri="http://schemas.openxmlformats.org/drawingml/2006/table">
            <a:tbl>
              <a:tblPr/>
              <a:tblGrid>
                <a:gridCol w="1066800">
                  <a:extLst>
                    <a:ext uri="{9D8B030D-6E8A-4147-A177-3AD203B41FA5}">
                      <a16:colId xmlns:a16="http://schemas.microsoft.com/office/drawing/2014/main" val="289418243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IN" sz="1400" b="0" i="0" u="none" strike="noStrike" dirty="0">
                          <a:effectLst/>
                          <a:latin typeface="Arial" panose="020B0604020202020204" pitchFamily="34" charset="0"/>
                        </a:rPr>
                        <a:t>****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4374365"/>
                  </a:ext>
                </a:extLst>
              </a:tr>
            </a:tbl>
          </a:graphicData>
        </a:graphic>
      </p:graphicFrame>
      <p:graphicFrame>
        <p:nvGraphicFramePr>
          <p:cNvPr id="19" name="Table 18">
            <a:extLst>
              <a:ext uri="{FF2B5EF4-FFF2-40B4-BE49-F238E27FC236}">
                <a16:creationId xmlns:a16="http://schemas.microsoft.com/office/drawing/2014/main" id="{5FD79F3D-F3C1-22AA-E367-FBE583E206F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01256828"/>
              </p:ext>
            </p:extLst>
          </p:nvPr>
        </p:nvGraphicFramePr>
        <p:xfrm>
          <a:off x="1539724" y="7477319"/>
          <a:ext cx="1066800" cy="220980"/>
        </p:xfrm>
        <a:graphic>
          <a:graphicData uri="http://schemas.openxmlformats.org/drawingml/2006/table">
            <a:tbl>
              <a:tblPr/>
              <a:tblGrid>
                <a:gridCol w="1066800">
                  <a:extLst>
                    <a:ext uri="{9D8B030D-6E8A-4147-A177-3AD203B41FA5}">
                      <a16:colId xmlns:a16="http://schemas.microsoft.com/office/drawing/2014/main" val="289418243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IN" sz="1400" b="0" i="0" u="none" strike="noStrike" dirty="0">
                          <a:effectLst/>
                          <a:latin typeface="Arial" panose="020B0604020202020204" pitchFamily="34" charset="0"/>
                        </a:rPr>
                        <a:t>****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4374365"/>
                  </a:ext>
                </a:extLst>
              </a:tr>
            </a:tbl>
          </a:graphicData>
        </a:graphic>
      </p:graphicFrame>
      <p:sp>
        <p:nvSpPr>
          <p:cNvPr id="20" name="TextBox 19">
            <a:extLst>
              <a:ext uri="{FF2B5EF4-FFF2-40B4-BE49-F238E27FC236}">
                <a16:creationId xmlns:a16="http://schemas.microsoft.com/office/drawing/2014/main" id="{D42DF3E1-CB85-1A71-32DF-188394E9E516}"/>
              </a:ext>
            </a:extLst>
          </p:cNvPr>
          <p:cNvSpPr txBox="1"/>
          <p:nvPr/>
        </p:nvSpPr>
        <p:spPr>
          <a:xfrm>
            <a:off x="248949" y="4145160"/>
            <a:ext cx="342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382E39E-BC84-89AC-18DF-E4DCC0230291}"/>
              </a:ext>
            </a:extLst>
          </p:cNvPr>
          <p:cNvSpPr txBox="1"/>
          <p:nvPr/>
        </p:nvSpPr>
        <p:spPr>
          <a:xfrm>
            <a:off x="203597" y="6812188"/>
            <a:ext cx="342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graphicFrame>
        <p:nvGraphicFramePr>
          <p:cNvPr id="22" name="Table 21">
            <a:extLst>
              <a:ext uri="{FF2B5EF4-FFF2-40B4-BE49-F238E27FC236}">
                <a16:creationId xmlns:a16="http://schemas.microsoft.com/office/drawing/2014/main" id="{CDD54941-9150-B9A9-4149-944F21DA289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080950"/>
              </p:ext>
            </p:extLst>
          </p:nvPr>
        </p:nvGraphicFramePr>
        <p:xfrm>
          <a:off x="5212477" y="5215419"/>
          <a:ext cx="1422400" cy="220980"/>
        </p:xfrm>
        <a:graphic>
          <a:graphicData uri="http://schemas.openxmlformats.org/drawingml/2006/table">
            <a:tbl>
              <a:tblPr/>
              <a:tblGrid>
                <a:gridCol w="1422400">
                  <a:extLst>
                    <a:ext uri="{9D8B030D-6E8A-4147-A177-3AD203B41FA5}">
                      <a16:colId xmlns:a16="http://schemas.microsoft.com/office/drawing/2014/main" val="922013210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IN" sz="1400" b="0" i="0" u="none" strike="noStrike" dirty="0">
                          <a:effectLst/>
                          <a:latin typeface="Arial" panose="020B0604020202020204" pitchFamily="34" charset="0"/>
                        </a:rPr>
                        <a:t>*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2348135"/>
                  </a:ext>
                </a:extLst>
              </a:tr>
            </a:tbl>
          </a:graphicData>
        </a:graphic>
      </p:graphicFrame>
      <p:graphicFrame>
        <p:nvGraphicFramePr>
          <p:cNvPr id="23" name="Table 22">
            <a:extLst>
              <a:ext uri="{FF2B5EF4-FFF2-40B4-BE49-F238E27FC236}">
                <a16:creationId xmlns:a16="http://schemas.microsoft.com/office/drawing/2014/main" id="{93B6651A-58EE-653B-A18D-2F8FA28DAAB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16422127"/>
              </p:ext>
            </p:extLst>
          </p:nvPr>
        </p:nvGraphicFramePr>
        <p:xfrm>
          <a:off x="5689997" y="7562331"/>
          <a:ext cx="1066800" cy="220980"/>
        </p:xfrm>
        <a:graphic>
          <a:graphicData uri="http://schemas.openxmlformats.org/drawingml/2006/table">
            <a:tbl>
              <a:tblPr/>
              <a:tblGrid>
                <a:gridCol w="1066800">
                  <a:extLst>
                    <a:ext uri="{9D8B030D-6E8A-4147-A177-3AD203B41FA5}">
                      <a16:colId xmlns:a16="http://schemas.microsoft.com/office/drawing/2014/main" val="289418243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IN" sz="1400" b="0" i="0" u="none" strike="noStrike" dirty="0">
                          <a:effectLst/>
                          <a:latin typeface="Arial" panose="020B0604020202020204" pitchFamily="34" charset="0"/>
                        </a:rPr>
                        <a:t>****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4374365"/>
                  </a:ext>
                </a:extLst>
              </a:tr>
            </a:tbl>
          </a:graphicData>
        </a:graphic>
      </p:graphicFrame>
      <p:graphicFrame>
        <p:nvGraphicFramePr>
          <p:cNvPr id="24" name="Table 23">
            <a:extLst>
              <a:ext uri="{FF2B5EF4-FFF2-40B4-BE49-F238E27FC236}">
                <a16:creationId xmlns:a16="http://schemas.microsoft.com/office/drawing/2014/main" id="{FBAD849E-04A8-9434-B6A3-F34609B4D88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19435641"/>
              </p:ext>
            </p:extLst>
          </p:nvPr>
        </p:nvGraphicFramePr>
        <p:xfrm>
          <a:off x="5080397" y="7562331"/>
          <a:ext cx="1066800" cy="220980"/>
        </p:xfrm>
        <a:graphic>
          <a:graphicData uri="http://schemas.openxmlformats.org/drawingml/2006/table">
            <a:tbl>
              <a:tblPr/>
              <a:tblGrid>
                <a:gridCol w="1066800">
                  <a:extLst>
                    <a:ext uri="{9D8B030D-6E8A-4147-A177-3AD203B41FA5}">
                      <a16:colId xmlns:a16="http://schemas.microsoft.com/office/drawing/2014/main" val="289418243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IN" sz="1400" b="0" i="0" u="none" strike="noStrike" dirty="0">
                          <a:effectLst/>
                          <a:latin typeface="Arial" panose="020B0604020202020204" pitchFamily="34" charset="0"/>
                        </a:rPr>
                        <a:t>****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437436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91365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B05F342-469F-41DF-8686-77589FFBEA0E}"/>
              </a:ext>
            </a:extLst>
          </p:cNvPr>
          <p:cNvSpPr txBox="1"/>
          <p:nvPr/>
        </p:nvSpPr>
        <p:spPr>
          <a:xfrm>
            <a:off x="127319" y="228600"/>
            <a:ext cx="67306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ure S7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9CB4B443-F29F-0CB8-2A91-550A5756F72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50235261"/>
              </p:ext>
            </p:extLst>
          </p:nvPr>
        </p:nvGraphicFramePr>
        <p:xfrm>
          <a:off x="2189596" y="73719"/>
          <a:ext cx="3303766" cy="822960"/>
        </p:xfrm>
        <a:graphic>
          <a:graphicData uri="http://schemas.openxmlformats.org/drawingml/2006/table">
            <a:tbl>
              <a:tblPr/>
              <a:tblGrid>
                <a:gridCol w="3303766">
                  <a:extLst>
                    <a:ext uri="{9D8B030D-6E8A-4147-A177-3AD203B41FA5}">
                      <a16:colId xmlns:a16="http://schemas.microsoft.com/office/drawing/2014/main" val="1586340438"/>
                    </a:ext>
                  </a:extLst>
                </a:gridCol>
              </a:tblGrid>
              <a:tr h="436729">
                <a:tc>
                  <a:txBody>
                    <a:bodyPr/>
                    <a:lstStyle/>
                    <a:p>
                      <a:pPr marL="0" indent="0" latinLnBrk="0">
                        <a:buFont typeface="Wingdings" panose="05000000000000000000" pitchFamily="2" charset="2"/>
                        <a:buNone/>
                      </a:pPr>
                      <a:r>
                        <a:rPr lang="en-IN" sz="1600" b="1" u="sng" dirty="0">
                          <a:effectLst/>
                        </a:rPr>
                        <a:t>Doubling time </a:t>
                      </a:r>
                    </a:p>
                    <a:p>
                      <a:pPr marL="285750" indent="-285750" latinLnBrk="0">
                        <a:buFont typeface="Wingdings" panose="05000000000000000000" pitchFamily="2" charset="2"/>
                        <a:buChar char="Ø"/>
                      </a:pPr>
                      <a:r>
                        <a:rPr lang="en-IN" sz="1600" b="1" dirty="0">
                          <a:effectLst/>
                        </a:rPr>
                        <a:t>20.91 to 25.94 hours for EV</a:t>
                      </a:r>
                    </a:p>
                    <a:p>
                      <a:pPr marL="285750" indent="-285750" latinLnBrk="0">
                        <a:buFont typeface="Wingdings" panose="05000000000000000000" pitchFamily="2" charset="2"/>
                        <a:buChar char="Ø"/>
                      </a:pPr>
                      <a:r>
                        <a:rPr lang="en-US" sz="1600" b="1" i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3.96 to 35.72 hours for RXRA OE</a:t>
                      </a:r>
                      <a:endParaRPr lang="en-IN" sz="1600" b="1" dirty="0">
                        <a:effectLst/>
                      </a:endParaRPr>
                    </a:p>
                  </a:txBody>
                  <a:tcPr anchor="ctr">
                    <a:lnL w="12700" cap="flat" cmpd="sng" algn="ctr">
                      <a:solidFill>
                        <a:srgbClr val="D1D1D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D1D1D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D1D1D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D1D1D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09102705"/>
                  </a:ext>
                </a:extLst>
              </a:tr>
            </a:tbl>
          </a:graphicData>
        </a:graphic>
      </p:graphicFrame>
      <p:sp>
        <p:nvSpPr>
          <p:cNvPr id="24" name="TextBox 23">
            <a:extLst>
              <a:ext uri="{FF2B5EF4-FFF2-40B4-BE49-F238E27FC236}">
                <a16:creationId xmlns:a16="http://schemas.microsoft.com/office/drawing/2014/main" id="{1F03CE60-E45A-9547-E34F-0F0AB8E9F143}"/>
              </a:ext>
            </a:extLst>
          </p:cNvPr>
          <p:cNvSpPr txBox="1"/>
          <p:nvPr/>
        </p:nvSpPr>
        <p:spPr>
          <a:xfrm>
            <a:off x="63659" y="3238840"/>
            <a:ext cx="67306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/>
              <a:t>Figure S8</a:t>
            </a:r>
          </a:p>
        </p:txBody>
      </p:sp>
      <p:pic>
        <p:nvPicPr>
          <p:cNvPr id="7" name="Picture 6" descr="A picture containing light, red, dark, night&#10;&#10;Description automatically generated">
            <a:extLst>
              <a:ext uri="{FF2B5EF4-FFF2-40B4-BE49-F238E27FC236}">
                <a16:creationId xmlns:a16="http://schemas.microsoft.com/office/drawing/2014/main" id="{4E153B8E-D2BA-9138-6B1A-F08E12205AA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1150" y="902178"/>
            <a:ext cx="3695700" cy="238658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111A520-3197-E0CC-0DE7-8B937F480BC7}"/>
              </a:ext>
            </a:extLst>
          </p:cNvPr>
          <p:cNvSpPr txBox="1"/>
          <p:nvPr/>
        </p:nvSpPr>
        <p:spPr>
          <a:xfrm>
            <a:off x="850256" y="3570224"/>
            <a:ext cx="342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E2ACC6C-5D38-E33F-BD37-16F4A2D62E9B}"/>
              </a:ext>
            </a:extLst>
          </p:cNvPr>
          <p:cNvSpPr txBox="1"/>
          <p:nvPr/>
        </p:nvSpPr>
        <p:spPr>
          <a:xfrm>
            <a:off x="850256" y="6538204"/>
            <a:ext cx="342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86E61E60-3373-7224-EC08-363B04FEC395}"/>
              </a:ext>
            </a:extLst>
          </p:cNvPr>
          <p:cNvGrpSpPr/>
          <p:nvPr/>
        </p:nvGrpSpPr>
        <p:grpSpPr>
          <a:xfrm>
            <a:off x="664759" y="3748302"/>
            <a:ext cx="3735147" cy="2990639"/>
            <a:chOff x="1143000" y="1745052"/>
            <a:chExt cx="3060700" cy="2471737"/>
          </a:xfrm>
        </p:grpSpPr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8460918D-31D4-8FDF-AEC7-2BA0AEBF63F0}"/>
                </a:ext>
              </a:extLst>
            </p:cNvPr>
            <p:cNvCxnSpPr/>
            <p:nvPr/>
          </p:nvCxnSpPr>
          <p:spPr>
            <a:xfrm>
              <a:off x="1963360" y="2589970"/>
              <a:ext cx="1846640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E08EDA6F-CA5F-B90A-56CA-740A19546ABB}"/>
                </a:ext>
              </a:extLst>
            </p:cNvPr>
            <p:cNvSpPr txBox="1"/>
            <p:nvPr/>
          </p:nvSpPr>
          <p:spPr>
            <a:xfrm>
              <a:off x="2842790" y="2669895"/>
              <a:ext cx="31372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/>
                <a:t>***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9B18A16-E4AC-1108-9E1E-A20F2021EB29}"/>
                </a:ext>
              </a:extLst>
            </p:cNvPr>
            <p:cNvSpPr txBox="1"/>
            <p:nvPr/>
          </p:nvSpPr>
          <p:spPr>
            <a:xfrm>
              <a:off x="3496280" y="2114550"/>
              <a:ext cx="31372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/>
                <a:t>**</a:t>
              </a:r>
            </a:p>
          </p:txBody>
        </p:sp>
        <p:pic>
          <p:nvPicPr>
            <p:cNvPr id="12" name="Picture 7" descr="C:\Users\BD Accuri\Desktop\STALLON\Lama84 normalized image\ligand jc1\KCL22 compiled.tif">
              <a:extLst>
                <a:ext uri="{FF2B5EF4-FFF2-40B4-BE49-F238E27FC236}">
                  <a16:creationId xmlns:a16="http://schemas.microsoft.com/office/drawing/2014/main" id="{222BC80B-65D2-7A35-4941-8DD432DB035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43000" y="1745052"/>
              <a:ext cx="3060700" cy="24717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8DD18B40-C57D-7AF0-6ECB-1A1BF18A18EB}"/>
              </a:ext>
            </a:extLst>
          </p:cNvPr>
          <p:cNvGrpSpPr/>
          <p:nvPr/>
        </p:nvGrpSpPr>
        <p:grpSpPr>
          <a:xfrm>
            <a:off x="664759" y="6653423"/>
            <a:ext cx="3735147" cy="2990639"/>
            <a:chOff x="4038600" y="1739301"/>
            <a:chExt cx="3060700" cy="2471737"/>
          </a:xfrm>
        </p:grpSpPr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7AB8AD71-CAB4-A6D9-33D9-59768C4AD5BF}"/>
                </a:ext>
              </a:extLst>
            </p:cNvPr>
            <p:cNvCxnSpPr/>
            <p:nvPr/>
          </p:nvCxnSpPr>
          <p:spPr>
            <a:xfrm>
              <a:off x="4848386" y="2582396"/>
              <a:ext cx="1844514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5" name="Picture 8" descr="C:\Users\BD Accuri\Desktop\STALLON\Lama84 normalized image\ligand jc1\Lama compiled.tif">
              <a:extLst>
                <a:ext uri="{FF2B5EF4-FFF2-40B4-BE49-F238E27FC236}">
                  <a16:creationId xmlns:a16="http://schemas.microsoft.com/office/drawing/2014/main" id="{7CDD6806-F734-D38F-61C2-F899B8705FB0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38600" y="1739301"/>
              <a:ext cx="3060700" cy="24717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06E08113-2018-A5BC-EF19-903CA3AF26B5}"/>
              </a:ext>
            </a:extLst>
          </p:cNvPr>
          <p:cNvSpPr txBox="1"/>
          <p:nvPr/>
        </p:nvSpPr>
        <p:spPr>
          <a:xfrm>
            <a:off x="1466852" y="3690685"/>
            <a:ext cx="91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200" b="1" dirty="0"/>
              <a:t>KCL2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CE8D2BD-F054-E55B-1AA7-14A825846B6E}"/>
              </a:ext>
            </a:extLst>
          </p:cNvPr>
          <p:cNvSpPr txBox="1"/>
          <p:nvPr/>
        </p:nvSpPr>
        <p:spPr>
          <a:xfrm>
            <a:off x="1447801" y="6630537"/>
            <a:ext cx="91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IN" sz="1200" b="1" dirty="0"/>
              <a:t>Lama84</a:t>
            </a:r>
          </a:p>
        </p:txBody>
      </p:sp>
    </p:spTree>
    <p:extLst>
      <p:ext uri="{BB962C8B-B14F-4D97-AF65-F5344CB8AC3E}">
        <p14:creationId xmlns:p14="http://schemas.microsoft.com/office/powerpoint/2010/main" val="398343424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C1DAFE7-D3DC-451A-B5BF-AD2E3C6EA0C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5561"/>
          <a:stretch/>
        </p:blipFill>
        <p:spPr>
          <a:xfrm>
            <a:off x="1124595" y="6411413"/>
            <a:ext cx="4535885" cy="3504112"/>
          </a:xfrm>
          <a:prstGeom prst="rect">
            <a:avLst/>
          </a:prstGeom>
          <a:ln w="28575">
            <a:noFill/>
          </a:ln>
        </p:spPr>
      </p:pic>
      <p:grpSp>
        <p:nvGrpSpPr>
          <p:cNvPr id="8" name="Group 7">
            <a:extLst>
              <a:ext uri="{FF2B5EF4-FFF2-40B4-BE49-F238E27FC236}">
                <a16:creationId xmlns:a16="http://schemas.microsoft.com/office/drawing/2014/main" id="{F5A25CFC-4DDF-42BE-90B5-1C9CD368B129}"/>
              </a:ext>
            </a:extLst>
          </p:cNvPr>
          <p:cNvGrpSpPr/>
          <p:nvPr/>
        </p:nvGrpSpPr>
        <p:grpSpPr>
          <a:xfrm>
            <a:off x="207959" y="3315010"/>
            <a:ext cx="7433509" cy="2574067"/>
            <a:chOff x="1114633" y="3127509"/>
            <a:chExt cx="9609588" cy="3553911"/>
          </a:xfrm>
        </p:grpSpPr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2AD42118-7216-42AD-9699-CFE23BFAA422}"/>
                </a:ext>
              </a:extLst>
            </p:cNvPr>
            <p:cNvGrpSpPr/>
            <p:nvPr/>
          </p:nvGrpSpPr>
          <p:grpSpPr>
            <a:xfrm>
              <a:off x="1114633" y="3351128"/>
              <a:ext cx="8468725" cy="3166789"/>
              <a:chOff x="324696" y="1036695"/>
              <a:chExt cx="8382154" cy="3085306"/>
            </a:xfrm>
          </p:grpSpPr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68AC8FBA-0E18-4405-A1EF-99679B54D232}"/>
                  </a:ext>
                </a:extLst>
              </p:cNvPr>
              <p:cNvSpPr txBox="1"/>
              <p:nvPr/>
            </p:nvSpPr>
            <p:spPr>
              <a:xfrm>
                <a:off x="6213849" y="1479852"/>
                <a:ext cx="2493001" cy="186300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/>
                  <a:t>1. Weekly monitoring of engraftment by </a:t>
                </a:r>
                <a:br>
                  <a:rPr lang="en-US" sz="1400" b="1" dirty="0"/>
                </a:br>
                <a:r>
                  <a:rPr lang="en-US" sz="1400" b="1" dirty="0"/>
                  <a:t>CD45 positive cells using flowcytometry </a:t>
                </a:r>
              </a:p>
              <a:p>
                <a:r>
                  <a:rPr lang="en-US" sz="1400" b="1" dirty="0"/>
                  <a:t>2. Survival</a:t>
                </a:r>
              </a:p>
              <a:p>
                <a:r>
                  <a:rPr lang="en-US" sz="1400" b="1" dirty="0"/>
                  <a:t>3. Spleen size</a:t>
                </a:r>
              </a:p>
            </p:txBody>
          </p:sp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2244BEFD-FBBB-4F05-81B2-6C4E0E0471B0}"/>
                  </a:ext>
                </a:extLst>
              </p:cNvPr>
              <p:cNvGrpSpPr/>
              <p:nvPr/>
            </p:nvGrpSpPr>
            <p:grpSpPr>
              <a:xfrm>
                <a:off x="324696" y="1036695"/>
                <a:ext cx="5645736" cy="3085306"/>
                <a:chOff x="552176" y="1036695"/>
                <a:chExt cx="5645736" cy="3085306"/>
              </a:xfrm>
            </p:grpSpPr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4809FB11-29EA-476C-B7BA-7B7796CFCE91}"/>
                    </a:ext>
                  </a:extLst>
                </p:cNvPr>
                <p:cNvSpPr txBox="1"/>
                <p:nvPr/>
              </p:nvSpPr>
              <p:spPr>
                <a:xfrm>
                  <a:off x="552176" y="2258996"/>
                  <a:ext cx="2143125" cy="186300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IN" sz="1400" dirty="0"/>
                    <a:t>Empty vector Lama84 cell line</a:t>
                  </a:r>
                </a:p>
                <a:p>
                  <a:pPr algn="ctr"/>
                  <a:r>
                    <a:rPr lang="en-IN" sz="1400" b="1" dirty="0"/>
                    <a:t>&amp;</a:t>
                  </a:r>
                </a:p>
                <a:p>
                  <a:pPr algn="ctr"/>
                  <a:r>
                    <a:rPr lang="en-IN" sz="1400" dirty="0"/>
                    <a:t>RXRA overexpressed Lama84 cell line (2*10^6 cells)</a:t>
                  </a:r>
                </a:p>
              </p:txBody>
            </p:sp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0888F8C7-E123-4F13-A753-D207268E3708}"/>
                    </a:ext>
                  </a:extLst>
                </p:cNvPr>
                <p:cNvSpPr txBox="1"/>
                <p:nvPr/>
              </p:nvSpPr>
              <p:spPr>
                <a:xfrm>
                  <a:off x="2997512" y="2167923"/>
                  <a:ext cx="1524000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/>
                    <a:t>Recipient  mice</a:t>
                  </a:r>
                </a:p>
              </p:txBody>
            </p:sp>
            <p:grpSp>
              <p:nvGrpSpPr>
                <p:cNvPr id="15" name="Group 66">
                  <a:extLst>
                    <a:ext uri="{FF2B5EF4-FFF2-40B4-BE49-F238E27FC236}">
                      <a16:creationId xmlns:a16="http://schemas.microsoft.com/office/drawing/2014/main" id="{937B51BC-0D39-44B3-BBDA-4CD3B68EE624}"/>
                    </a:ext>
                  </a:extLst>
                </p:cNvPr>
                <p:cNvGrpSpPr/>
                <p:nvPr/>
              </p:nvGrpSpPr>
              <p:grpSpPr>
                <a:xfrm>
                  <a:off x="1612263" y="1558323"/>
                  <a:ext cx="506101" cy="607441"/>
                  <a:chOff x="877005" y="4204647"/>
                  <a:chExt cx="449868" cy="607441"/>
                </a:xfrm>
              </p:grpSpPr>
              <p:sp>
                <p:nvSpPr>
                  <p:cNvPr id="24" name="Flowchart: Connector 23">
                    <a:extLst>
                      <a:ext uri="{FF2B5EF4-FFF2-40B4-BE49-F238E27FC236}">
                        <a16:creationId xmlns:a16="http://schemas.microsoft.com/office/drawing/2014/main" id="{7494AD4C-F317-43F6-844F-9921B15FFA61}"/>
                      </a:ext>
                    </a:extLst>
                  </p:cNvPr>
                  <p:cNvSpPr/>
                  <p:nvPr/>
                </p:nvSpPr>
                <p:spPr>
                  <a:xfrm>
                    <a:off x="954341" y="4204647"/>
                    <a:ext cx="145070" cy="163889"/>
                  </a:xfrm>
                  <a:prstGeom prst="flowChartConnector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000"/>
                  </a:p>
                </p:txBody>
              </p:sp>
              <p:sp>
                <p:nvSpPr>
                  <p:cNvPr id="25" name="Flowchart: Connector 24">
                    <a:extLst>
                      <a:ext uri="{FF2B5EF4-FFF2-40B4-BE49-F238E27FC236}">
                        <a16:creationId xmlns:a16="http://schemas.microsoft.com/office/drawing/2014/main" id="{9D2F9D44-59DC-4866-9BB6-4ADB8E581F61}"/>
                      </a:ext>
                    </a:extLst>
                  </p:cNvPr>
                  <p:cNvSpPr/>
                  <p:nvPr/>
                </p:nvSpPr>
                <p:spPr>
                  <a:xfrm>
                    <a:off x="877005" y="4419599"/>
                    <a:ext cx="145070" cy="163889"/>
                  </a:xfrm>
                  <a:prstGeom prst="flowChartConnector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000"/>
                  </a:p>
                </p:txBody>
              </p:sp>
              <p:sp>
                <p:nvSpPr>
                  <p:cNvPr id="26" name="Flowchart: Connector 25">
                    <a:extLst>
                      <a:ext uri="{FF2B5EF4-FFF2-40B4-BE49-F238E27FC236}">
                        <a16:creationId xmlns:a16="http://schemas.microsoft.com/office/drawing/2014/main" id="{89781004-626A-4B1D-8BD8-567E853B7715}"/>
                      </a:ext>
                    </a:extLst>
                  </p:cNvPr>
                  <p:cNvSpPr/>
                  <p:nvPr/>
                </p:nvSpPr>
                <p:spPr>
                  <a:xfrm>
                    <a:off x="956870" y="4648199"/>
                    <a:ext cx="145070" cy="163889"/>
                  </a:xfrm>
                  <a:prstGeom prst="flowChartConnector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000"/>
                  </a:p>
                </p:txBody>
              </p:sp>
              <p:sp>
                <p:nvSpPr>
                  <p:cNvPr id="27" name="Flowchart: Connector 26">
                    <a:extLst>
                      <a:ext uri="{FF2B5EF4-FFF2-40B4-BE49-F238E27FC236}">
                        <a16:creationId xmlns:a16="http://schemas.microsoft.com/office/drawing/2014/main" id="{4E4F4178-1199-449F-92CF-D74AEB18D23A}"/>
                      </a:ext>
                    </a:extLst>
                  </p:cNvPr>
                  <p:cNvSpPr/>
                  <p:nvPr/>
                </p:nvSpPr>
                <p:spPr>
                  <a:xfrm>
                    <a:off x="1089806" y="4405729"/>
                    <a:ext cx="145070" cy="163889"/>
                  </a:xfrm>
                  <a:prstGeom prst="flowChartConnector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000"/>
                  </a:p>
                </p:txBody>
              </p:sp>
              <p:sp>
                <p:nvSpPr>
                  <p:cNvPr id="28" name="Flowchart: Connector 27">
                    <a:extLst>
                      <a:ext uri="{FF2B5EF4-FFF2-40B4-BE49-F238E27FC236}">
                        <a16:creationId xmlns:a16="http://schemas.microsoft.com/office/drawing/2014/main" id="{AB98DF8F-647D-4A43-8AF9-5BD8A1B0EA68}"/>
                      </a:ext>
                    </a:extLst>
                  </p:cNvPr>
                  <p:cNvSpPr/>
                  <p:nvPr/>
                </p:nvSpPr>
                <p:spPr>
                  <a:xfrm>
                    <a:off x="1181803" y="4634329"/>
                    <a:ext cx="145070" cy="163889"/>
                  </a:xfrm>
                  <a:prstGeom prst="flowChartConnector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000"/>
                  </a:p>
                </p:txBody>
              </p:sp>
            </p:grpSp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EC281513-4A34-40B3-877D-169BE35AC7EA}"/>
                    </a:ext>
                  </a:extLst>
                </p:cNvPr>
                <p:cNvSpPr txBox="1"/>
                <p:nvPr/>
              </p:nvSpPr>
              <p:spPr>
                <a:xfrm>
                  <a:off x="2842268" y="1036695"/>
                  <a:ext cx="1600200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/>
                    <a:t>Irradiation -</a:t>
                  </a:r>
                  <a:r>
                    <a:rPr lang="en-US" sz="1200" dirty="0">
                      <a:solidFill>
                        <a:srgbClr val="212121"/>
                      </a:solidFill>
                      <a:ea typeface="Calibri" panose="020F0502020204030204" pitchFamily="34" charset="0"/>
                    </a:rPr>
                    <a:t>250cGy</a:t>
                  </a:r>
                  <a:endParaRPr lang="en-US" sz="1200" dirty="0"/>
                </a:p>
              </p:txBody>
            </p:sp>
            <p:pic>
              <p:nvPicPr>
                <p:cNvPr id="17" name="Picture 2" descr="C:\Users\admin\Desktop\00555720150527t194627.jpg">
                  <a:extLst>
                    <a:ext uri="{FF2B5EF4-FFF2-40B4-BE49-F238E27FC236}">
                      <a16:creationId xmlns:a16="http://schemas.microsoft.com/office/drawing/2014/main" id="{F39A055C-E80E-4CD6-9AA9-256473FFC531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3" cstate="print"/>
                <a:srcRect/>
                <a:stretch>
                  <a:fillRect/>
                </a:stretch>
              </p:blipFill>
              <p:spPr bwMode="auto">
                <a:xfrm>
                  <a:off x="3226112" y="1558323"/>
                  <a:ext cx="1400811" cy="685800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182BAABB-5F74-4038-8548-6AC80F20AEA6}"/>
                    </a:ext>
                  </a:extLst>
                </p:cNvPr>
                <p:cNvSpPr txBox="1"/>
                <p:nvPr/>
              </p:nvSpPr>
              <p:spPr>
                <a:xfrm>
                  <a:off x="2692712" y="2445427"/>
                  <a:ext cx="2143125" cy="523220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dirty="0"/>
                    <a:t>8-10 weeks</a:t>
                  </a:r>
                </a:p>
                <a:p>
                  <a:pPr algn="ctr"/>
                  <a:r>
                    <a:rPr lang="en-US" sz="1400" dirty="0"/>
                    <a:t>NOD/SCID/IL-2R</a:t>
                  </a:r>
                  <a:r>
                    <a:rPr lang="el-GR" sz="1400" dirty="0"/>
                    <a:t>γ-/- (</a:t>
                  </a:r>
                  <a:r>
                    <a:rPr lang="en-US" sz="1400" dirty="0"/>
                    <a:t>NSG) </a:t>
                  </a:r>
                </a:p>
              </p:txBody>
            </p:sp>
            <p:sp>
              <p:nvSpPr>
                <p:cNvPr id="19" name="Right Arrow 12">
                  <a:extLst>
                    <a:ext uri="{FF2B5EF4-FFF2-40B4-BE49-F238E27FC236}">
                      <a16:creationId xmlns:a16="http://schemas.microsoft.com/office/drawing/2014/main" id="{F5716F8C-AE75-485A-B510-418246D8CBBE}"/>
                    </a:ext>
                  </a:extLst>
                </p:cNvPr>
                <p:cNvSpPr/>
                <p:nvPr/>
              </p:nvSpPr>
              <p:spPr>
                <a:xfrm>
                  <a:off x="2616512" y="1786923"/>
                  <a:ext cx="396824" cy="124882"/>
                </a:xfrm>
                <a:prstGeom prst="rightArrow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/>
                </a:p>
              </p:txBody>
            </p:sp>
            <p:sp>
              <p:nvSpPr>
                <p:cNvPr id="20" name="Right Arrow 13">
                  <a:extLst>
                    <a:ext uri="{FF2B5EF4-FFF2-40B4-BE49-F238E27FC236}">
                      <a16:creationId xmlns:a16="http://schemas.microsoft.com/office/drawing/2014/main" id="{2AC476F4-2A61-4D6E-948C-86A01BBA5CAA}"/>
                    </a:ext>
                  </a:extLst>
                </p:cNvPr>
                <p:cNvSpPr/>
                <p:nvPr/>
              </p:nvSpPr>
              <p:spPr>
                <a:xfrm>
                  <a:off x="4673912" y="1863123"/>
                  <a:ext cx="1524000" cy="124882"/>
                </a:xfrm>
                <a:prstGeom prst="rightArrow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/>
                </a:p>
              </p:txBody>
            </p:sp>
            <p:sp>
              <p:nvSpPr>
                <p:cNvPr id="21" name="Lightning Bolt 20">
                  <a:extLst>
                    <a:ext uri="{FF2B5EF4-FFF2-40B4-BE49-F238E27FC236}">
                      <a16:creationId xmlns:a16="http://schemas.microsoft.com/office/drawing/2014/main" id="{C4079B9A-0934-46CD-998F-CAC53C403FEE}"/>
                    </a:ext>
                  </a:extLst>
                </p:cNvPr>
                <p:cNvSpPr/>
                <p:nvPr/>
              </p:nvSpPr>
              <p:spPr>
                <a:xfrm>
                  <a:off x="2921312" y="1308172"/>
                  <a:ext cx="301955" cy="343363"/>
                </a:xfrm>
                <a:prstGeom prst="lightningBolt">
                  <a:avLst/>
                </a:prstGeom>
                <a:solidFill>
                  <a:schemeClr val="accent2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/>
                </a:p>
              </p:txBody>
            </p:sp>
            <p:sp>
              <p:nvSpPr>
                <p:cNvPr id="22" name="Flowchart: Connector 21">
                  <a:extLst>
                    <a:ext uri="{FF2B5EF4-FFF2-40B4-BE49-F238E27FC236}">
                      <a16:creationId xmlns:a16="http://schemas.microsoft.com/office/drawing/2014/main" id="{93C44FE6-7101-49A7-8837-6603F1A8CE23}"/>
                    </a:ext>
                  </a:extLst>
                </p:cNvPr>
                <p:cNvSpPr/>
                <p:nvPr/>
              </p:nvSpPr>
              <p:spPr>
                <a:xfrm>
                  <a:off x="1960282" y="1546864"/>
                  <a:ext cx="163204" cy="163889"/>
                </a:xfrm>
                <a:prstGeom prst="flowChartConnector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/>
                </a:p>
              </p:txBody>
            </p:sp>
            <p:sp>
              <p:nvSpPr>
                <p:cNvPr id="23" name="Flowchart: Connector 22">
                  <a:extLst>
                    <a:ext uri="{FF2B5EF4-FFF2-40B4-BE49-F238E27FC236}">
                      <a16:creationId xmlns:a16="http://schemas.microsoft.com/office/drawing/2014/main" id="{A530A045-F33C-485E-84C3-9B08C1E063AD}"/>
                    </a:ext>
                  </a:extLst>
                </p:cNvPr>
                <p:cNvSpPr/>
                <p:nvPr/>
              </p:nvSpPr>
              <p:spPr>
                <a:xfrm>
                  <a:off x="2089651" y="1771566"/>
                  <a:ext cx="163204" cy="163889"/>
                </a:xfrm>
                <a:prstGeom prst="flowChartConnector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000"/>
                </a:p>
              </p:txBody>
            </p:sp>
          </p:grpSp>
        </p:grp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D05359C0-6D69-4454-9D53-57062626224F}"/>
                </a:ext>
              </a:extLst>
            </p:cNvPr>
            <p:cNvSpPr/>
            <p:nvPr/>
          </p:nvSpPr>
          <p:spPr>
            <a:xfrm>
              <a:off x="1748897" y="3127509"/>
              <a:ext cx="8975324" cy="355391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dirty="0"/>
            </a:p>
          </p:txBody>
        </p: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3ACC239C-6EC3-4C25-B77F-0F21D034BC20}"/>
              </a:ext>
            </a:extLst>
          </p:cNvPr>
          <p:cNvSpPr txBox="1"/>
          <p:nvPr/>
        </p:nvSpPr>
        <p:spPr>
          <a:xfrm>
            <a:off x="207959" y="223967"/>
            <a:ext cx="63582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ure S9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86F494D-685B-B44C-97E1-140FBE65D07E}"/>
              </a:ext>
            </a:extLst>
          </p:cNvPr>
          <p:cNvSpPr txBox="1"/>
          <p:nvPr/>
        </p:nvSpPr>
        <p:spPr>
          <a:xfrm>
            <a:off x="527145" y="3165544"/>
            <a:ext cx="342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E14193C-D927-97F3-C537-DF43C0729479}"/>
              </a:ext>
            </a:extLst>
          </p:cNvPr>
          <p:cNvSpPr txBox="1"/>
          <p:nvPr/>
        </p:nvSpPr>
        <p:spPr>
          <a:xfrm>
            <a:off x="693560" y="6009909"/>
            <a:ext cx="342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DB21779-6003-002E-AF0D-4A652455CED0}"/>
              </a:ext>
            </a:extLst>
          </p:cNvPr>
          <p:cNvSpPr txBox="1"/>
          <p:nvPr/>
        </p:nvSpPr>
        <p:spPr>
          <a:xfrm>
            <a:off x="2968290" y="6109845"/>
            <a:ext cx="848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EV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FCF0B41-B1C9-786F-4FF2-C95196031969}"/>
              </a:ext>
            </a:extLst>
          </p:cNvPr>
          <p:cNvSpPr txBox="1"/>
          <p:nvPr/>
        </p:nvSpPr>
        <p:spPr>
          <a:xfrm>
            <a:off x="4393056" y="6109845"/>
            <a:ext cx="13174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dirty="0"/>
              <a:t>RXRA OE</a:t>
            </a:r>
          </a:p>
        </p:txBody>
      </p:sp>
      <p:pic>
        <p:nvPicPr>
          <p:cNvPr id="7" name="Picture 6" descr="Chart, bar chart&#10;&#10;Description automatically generated">
            <a:extLst>
              <a:ext uri="{FF2B5EF4-FFF2-40B4-BE49-F238E27FC236}">
                <a16:creationId xmlns:a16="http://schemas.microsoft.com/office/drawing/2014/main" id="{E8AAFEA8-425D-3DFF-155A-C15732730C5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4" t="5593" r="6280" b="5867"/>
          <a:stretch/>
        </p:blipFill>
        <p:spPr>
          <a:xfrm>
            <a:off x="917198" y="716312"/>
            <a:ext cx="4950679" cy="2243368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B1F83B0C-5AE1-7E47-88CF-351B65A17058}"/>
              </a:ext>
            </a:extLst>
          </p:cNvPr>
          <p:cNvSpPr txBox="1"/>
          <p:nvPr/>
        </p:nvSpPr>
        <p:spPr>
          <a:xfrm>
            <a:off x="1134525" y="113060"/>
            <a:ext cx="342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128FB93-4A4E-1082-680D-71BAF6DBE569}"/>
              </a:ext>
            </a:extLst>
          </p:cNvPr>
          <p:cNvSpPr txBox="1"/>
          <p:nvPr/>
        </p:nvSpPr>
        <p:spPr>
          <a:xfrm>
            <a:off x="3792402" y="48180"/>
            <a:ext cx="342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7294945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87</TotalTime>
  <Words>217</Words>
  <Application>Microsoft Office PowerPoint</Application>
  <PresentationFormat>A4 Paper (210x297 mm)</PresentationFormat>
  <Paragraphs>91</Paragraphs>
  <Slides>7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Wingdings</vt:lpstr>
      <vt:lpstr>Office Theme</vt:lpstr>
      <vt:lpstr>Prism 7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D Accuri</dc:creator>
  <cp:lastModifiedBy>Bharathi M.R.</cp:lastModifiedBy>
  <cp:revision>72</cp:revision>
  <dcterms:created xsi:type="dcterms:W3CDTF">2006-08-16T00:00:00Z</dcterms:created>
  <dcterms:modified xsi:type="dcterms:W3CDTF">2023-04-28T09:11:06Z</dcterms:modified>
</cp:coreProperties>
</file>